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75" d="100"/>
          <a:sy n="75" d="100"/>
        </p:scale>
        <p:origin x="-1704" y="-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3099AF-EDEC-0F44-83CA-0F0D1DAFAD74}" type="datetimeFigureOut">
              <a:rPr lang="en-US" smtClean="0"/>
              <a:t>1/2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7453F-9204-EC44-BDFE-2FF29166CB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3195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3099AF-EDEC-0F44-83CA-0F0D1DAFAD74}" type="datetimeFigureOut">
              <a:rPr lang="en-US" smtClean="0"/>
              <a:t>1/2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7453F-9204-EC44-BDFE-2FF29166CB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32906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3099AF-EDEC-0F44-83CA-0F0D1DAFAD74}" type="datetimeFigureOut">
              <a:rPr lang="en-US" smtClean="0"/>
              <a:t>1/2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7453F-9204-EC44-BDFE-2FF29166CB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1827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3099AF-EDEC-0F44-83CA-0F0D1DAFAD74}" type="datetimeFigureOut">
              <a:rPr lang="en-US" smtClean="0"/>
              <a:t>1/2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7453F-9204-EC44-BDFE-2FF29166CB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82959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3099AF-EDEC-0F44-83CA-0F0D1DAFAD74}" type="datetimeFigureOut">
              <a:rPr lang="en-US" smtClean="0"/>
              <a:t>1/2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7453F-9204-EC44-BDFE-2FF29166CB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53529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3099AF-EDEC-0F44-83CA-0F0D1DAFAD74}" type="datetimeFigureOut">
              <a:rPr lang="en-US" smtClean="0"/>
              <a:t>1/20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7453F-9204-EC44-BDFE-2FF29166CB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67844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3099AF-EDEC-0F44-83CA-0F0D1DAFAD74}" type="datetimeFigureOut">
              <a:rPr lang="en-US" smtClean="0"/>
              <a:t>1/20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7453F-9204-EC44-BDFE-2FF29166CB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64130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3099AF-EDEC-0F44-83CA-0F0D1DAFAD74}" type="datetimeFigureOut">
              <a:rPr lang="en-US" smtClean="0"/>
              <a:t>1/20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7453F-9204-EC44-BDFE-2FF29166CB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97012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3099AF-EDEC-0F44-83CA-0F0D1DAFAD74}" type="datetimeFigureOut">
              <a:rPr lang="en-US" smtClean="0"/>
              <a:t>1/20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7453F-9204-EC44-BDFE-2FF29166CB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06094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3099AF-EDEC-0F44-83CA-0F0D1DAFAD74}" type="datetimeFigureOut">
              <a:rPr lang="en-US" smtClean="0"/>
              <a:t>1/20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7453F-9204-EC44-BDFE-2FF29166CB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44514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3099AF-EDEC-0F44-83CA-0F0D1DAFAD74}" type="datetimeFigureOut">
              <a:rPr lang="en-US" smtClean="0"/>
              <a:t>1/20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7453F-9204-EC44-BDFE-2FF29166CB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47066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3099AF-EDEC-0F44-83CA-0F0D1DAFAD74}" type="datetimeFigureOut">
              <a:rPr lang="en-US" smtClean="0"/>
              <a:t>1/2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07453F-9204-EC44-BDFE-2FF29166CB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23796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TextBox 127"/>
          <p:cNvSpPr txBox="1"/>
          <p:nvPr/>
        </p:nvSpPr>
        <p:spPr>
          <a:xfrm>
            <a:off x="31053" y="-15998"/>
            <a:ext cx="16602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dditional </a:t>
            </a:r>
            <a:r>
              <a:rPr lang="en-US" smtClean="0"/>
              <a:t>file </a:t>
            </a:r>
            <a:r>
              <a:rPr lang="en-US" smtClean="0"/>
              <a:t>3</a:t>
            </a:r>
            <a:endParaRPr lang="en-US" dirty="0"/>
          </a:p>
        </p:txBody>
      </p:sp>
      <p:pic>
        <p:nvPicPr>
          <p:cNvPr id="2" name="Picture 1" descr="graph2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933"/>
          <a:stretch/>
        </p:blipFill>
        <p:spPr>
          <a:xfrm>
            <a:off x="558186" y="1047889"/>
            <a:ext cx="3558832" cy="2045970"/>
          </a:xfrm>
          <a:prstGeom prst="rect">
            <a:avLst/>
          </a:prstGeom>
        </p:spPr>
      </p:pic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12631728"/>
              </p:ext>
            </p:extLst>
          </p:nvPr>
        </p:nvGraphicFramePr>
        <p:xfrm>
          <a:off x="558186" y="4182194"/>
          <a:ext cx="5444333" cy="2048594"/>
        </p:xfrm>
        <a:graphic>
          <a:graphicData uri="http://schemas.openxmlformats.org/drawingml/2006/table">
            <a:tbl>
              <a:tblPr/>
              <a:tblGrid>
                <a:gridCol w="873682"/>
                <a:gridCol w="4570651"/>
              </a:tblGrid>
              <a:tr h="23498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nsert name</a:t>
                      </a:r>
                    </a:p>
                  </a:txBody>
                  <a:tcPr marL="8576" marR="8576" marT="85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lanking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equence identified by TEM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76" marR="8576" marT="85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759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empUni1</a:t>
                      </a:r>
                    </a:p>
                  </a:txBody>
                  <a:tcPr marL="8576" marR="8576" marT="85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GCACAATCCGCGTCGGTCAATGTCCCGAGCCGATTGGCGGACCGGCACAAACCGTTCCACATCCGACCGAGACACATCGCCGGCCCCCATCCGCTTCCC(ACB053:89:D260YACXX:7:1216:7500:83667)</a:t>
                      </a:r>
                    </a:p>
                  </a:txBody>
                  <a:tcPr marL="8576" marR="8576" marT="85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9052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empUni2</a:t>
                      </a:r>
                    </a:p>
                  </a:txBody>
                  <a:tcPr marL="8576" marR="8576" marT="85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GTAAAGTTGCCAGAGTACGCTTAACCTCTGGATTTGAAATCACTGCTTATATACCCGGTATTGGCCATAATTTACAAGAACATTCTGTAGTCTTAGTA(ACB053:89:D260YACXX:7:2110:19812:74864)</a:t>
                      </a:r>
                    </a:p>
                  </a:txBody>
                  <a:tcPr marL="8576" marR="8576" marT="85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471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empUni3</a:t>
                      </a:r>
                    </a:p>
                  </a:txBody>
                  <a:tcPr marL="8576" marR="8576" marT="85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CCTATTGTATCTGCTTGACCTTTCCTAAGTGGAGACAGAATAAAGCGTCCATAATAAAGACGCTTACTGTCTACCCTTGATTCAACACACTTCCATTGT(ACB053:89:D260YACXX:7:2314:8900:38336)</a:t>
                      </a:r>
                    </a:p>
                  </a:txBody>
                  <a:tcPr marL="8576" marR="8576" marT="85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585111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6</TotalTime>
  <Words>61</Words>
  <Application>Microsoft Macintosh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rome</dc:creator>
  <cp:lastModifiedBy>Renyi Liu</cp:lastModifiedBy>
  <cp:revision>7</cp:revision>
  <dcterms:created xsi:type="dcterms:W3CDTF">2014-10-30T05:01:11Z</dcterms:created>
  <dcterms:modified xsi:type="dcterms:W3CDTF">2015-01-20T02:09:54Z</dcterms:modified>
</cp:coreProperties>
</file>